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3" d="100"/>
          <a:sy n="83" d="100"/>
        </p:scale>
        <p:origin x="291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&#24037;&#20316;&#31807;2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umos\Desktop\cis-elements%20in%20promoters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Lumos\Desktop\cis-elements%20in%20promoters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solidFill>
                <a:schemeClr val="accent1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1837-4D6E-9746-5421A40B3B25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1837-4D6E-9746-5421A40B3B25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1837-4D6E-9746-5421A40B3B25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1837-4D6E-9746-5421A40B3B25}"/>
              </c:ext>
            </c:extLst>
          </c:dPt>
          <c:dPt>
            <c:idx val="4"/>
            <c:bubble3D val="0"/>
            <c:spPr>
              <a:solidFill>
                <a:srgbClr val="FF0000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1837-4D6E-9746-5421A40B3B25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1837-4D6E-9746-5421A40B3B25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 w="19050">
                <a:solidFill>
                  <a:schemeClr val="lt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1837-4D6E-9746-5421A40B3B25}"/>
              </c:ext>
            </c:extLst>
          </c:dPt>
          <c:cat>
            <c:strRef>
              <c:f>Sheet2!$A$56:$A$62</c:f>
              <c:strCache>
                <c:ptCount val="7"/>
                <c:pt idx="0">
                  <c:v>Light responsive elements</c:v>
                </c:pt>
                <c:pt idx="1">
                  <c:v>Hormone responsive elements</c:v>
                </c:pt>
                <c:pt idx="2">
                  <c:v>Site binding responsive elements</c:v>
                </c:pt>
                <c:pt idx="3">
                  <c:v>Sress responsive elements</c:v>
                </c:pt>
                <c:pt idx="4">
                  <c:v>Growth responsive elements</c:v>
                </c:pt>
                <c:pt idx="5">
                  <c:v>Core promoter elements</c:v>
                </c:pt>
                <c:pt idx="6">
                  <c:v>Common cis-acting elements</c:v>
                </c:pt>
              </c:strCache>
            </c:strRef>
          </c:cat>
          <c:val>
            <c:numRef>
              <c:f>Sheet2!$B$56:$B$62</c:f>
              <c:numCache>
                <c:formatCode>General</c:formatCode>
                <c:ptCount val="7"/>
                <c:pt idx="0">
                  <c:v>454</c:v>
                </c:pt>
                <c:pt idx="1">
                  <c:v>276</c:v>
                </c:pt>
                <c:pt idx="2">
                  <c:v>26</c:v>
                </c:pt>
                <c:pt idx="3">
                  <c:v>149</c:v>
                </c:pt>
                <c:pt idx="4">
                  <c:v>82</c:v>
                </c:pt>
                <c:pt idx="5">
                  <c:v>2089</c:v>
                </c:pt>
                <c:pt idx="6">
                  <c:v>6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1837-4D6E-9746-5421A40B3B2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 rtl="0">
            <a:defRPr sz="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045760584274793"/>
          <c:y val="4.3528968330799535E-2"/>
          <c:w val="0.82048999727876826"/>
          <c:h val="0.7095400950423466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2!$E$2:$E$6</c:f>
              <c:strCache>
                <c:ptCount val="5"/>
                <c:pt idx="0">
                  <c:v>Auxin</c:v>
                </c:pt>
                <c:pt idx="1">
                  <c:v>Gibberellin</c:v>
                </c:pt>
                <c:pt idx="2">
                  <c:v>Salicylic acid</c:v>
                </c:pt>
                <c:pt idx="3">
                  <c:v>Abscisic acid</c:v>
                </c:pt>
                <c:pt idx="4">
                  <c:v>MeJA</c:v>
                </c:pt>
              </c:strCache>
            </c:strRef>
          </c:cat>
          <c:val>
            <c:numRef>
              <c:f>Sheet2!$F$2:$F$6</c:f>
              <c:numCache>
                <c:formatCode>General</c:formatCode>
                <c:ptCount val="5"/>
                <c:pt idx="0">
                  <c:v>20</c:v>
                </c:pt>
                <c:pt idx="1">
                  <c:v>44</c:v>
                </c:pt>
                <c:pt idx="2">
                  <c:v>37</c:v>
                </c:pt>
                <c:pt idx="3">
                  <c:v>69</c:v>
                </c:pt>
                <c:pt idx="4">
                  <c:v>1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916-4D1E-855C-A84A1474D13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645431999"/>
        <c:axId val="1645432831"/>
      </c:barChart>
      <c:catAx>
        <c:axId val="164543199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45432831"/>
        <c:crosses val="autoZero"/>
        <c:auto val="1"/>
        <c:lblAlgn val="ctr"/>
        <c:lblOffset val="100"/>
        <c:noMultiLvlLbl val="0"/>
      </c:catAx>
      <c:valAx>
        <c:axId val="1645432831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4543199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069918099702421"/>
          <c:y val="1.7102614481140008E-2"/>
          <c:w val="0.69863850630711288"/>
          <c:h val="0.6188857331814896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strRef>
              <c:f>Sheet2!$E$10:$E$15</c:f>
              <c:strCache>
                <c:ptCount val="6"/>
                <c:pt idx="0">
                  <c:v>Defense and stress</c:v>
                </c:pt>
                <c:pt idx="1">
                  <c:v>Light</c:v>
                </c:pt>
                <c:pt idx="2">
                  <c:v>Low-temperature</c:v>
                </c:pt>
                <c:pt idx="3">
                  <c:v>Anaerobic induction</c:v>
                </c:pt>
                <c:pt idx="4">
                  <c:v>Drought</c:v>
                </c:pt>
                <c:pt idx="5">
                  <c:v>Elicitor-mediated activation</c:v>
                </c:pt>
              </c:strCache>
            </c:strRef>
          </c:cat>
          <c:val>
            <c:numRef>
              <c:f>Sheet2!$F$10:$F$15</c:f>
              <c:numCache>
                <c:formatCode>General</c:formatCode>
                <c:ptCount val="6"/>
                <c:pt idx="0">
                  <c:v>14</c:v>
                </c:pt>
                <c:pt idx="1">
                  <c:v>454</c:v>
                </c:pt>
                <c:pt idx="2">
                  <c:v>28</c:v>
                </c:pt>
                <c:pt idx="3">
                  <c:v>79</c:v>
                </c:pt>
                <c:pt idx="4">
                  <c:v>26</c:v>
                </c:pt>
                <c:pt idx="5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A9D-49E2-BD03-82915FE1999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71764863"/>
        <c:axId val="171764031"/>
      </c:barChart>
      <c:catAx>
        <c:axId val="171764863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1764031"/>
        <c:crosses val="autoZero"/>
        <c:auto val="1"/>
        <c:lblAlgn val="ctr"/>
        <c:lblOffset val="100"/>
        <c:noMultiLvlLbl val="0"/>
      </c:catAx>
      <c:valAx>
        <c:axId val="171764031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1764863"/>
        <c:crosses val="autoZero"/>
        <c:crossBetween val="between"/>
        <c:majorUnit val="1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922836082713108"/>
          <c:y val="2.8174860461752334E-2"/>
          <c:w val="0.71515233796150679"/>
          <c:h val="0.51390911003406681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4"/>
            </a:solidFill>
            <a:ln>
              <a:noFill/>
            </a:ln>
            <a:effectLst/>
          </c:spPr>
          <c:invertIfNegative val="0"/>
          <c:cat>
            <c:strRef>
              <c:f>Sheet2!$E$19:$E$25</c:f>
              <c:strCache>
                <c:ptCount val="7"/>
                <c:pt idx="0">
                  <c:v>Circadian control</c:v>
                </c:pt>
                <c:pt idx="1">
                  <c:v>Seed</c:v>
                </c:pt>
                <c:pt idx="2">
                  <c:v>Zein metabolism regulation</c:v>
                </c:pt>
                <c:pt idx="3">
                  <c:v>Meristem expression</c:v>
                </c:pt>
                <c:pt idx="4">
                  <c:v>Endosperm expression</c:v>
                </c:pt>
                <c:pt idx="5">
                  <c:v>Differentiation of the palisade mesophyll cells</c:v>
                </c:pt>
                <c:pt idx="6">
                  <c:v>flavonoid biosynthsis</c:v>
                </c:pt>
              </c:strCache>
            </c:strRef>
          </c:cat>
          <c:val>
            <c:numRef>
              <c:f>Sheet2!$F$19:$F$25</c:f>
              <c:numCache>
                <c:formatCode>General</c:formatCode>
                <c:ptCount val="7"/>
                <c:pt idx="0">
                  <c:v>11</c:v>
                </c:pt>
                <c:pt idx="1">
                  <c:v>1</c:v>
                </c:pt>
                <c:pt idx="2">
                  <c:v>25</c:v>
                </c:pt>
                <c:pt idx="3">
                  <c:v>20</c:v>
                </c:pt>
                <c:pt idx="4">
                  <c:v>10</c:v>
                </c:pt>
                <c:pt idx="5">
                  <c:v>13</c:v>
                </c:pt>
                <c:pt idx="6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BAB-45F9-86B0-82F81F19CE6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50"/>
        <c:overlap val="-27"/>
        <c:axId val="172996991"/>
        <c:axId val="1900684943"/>
      </c:barChart>
      <c:catAx>
        <c:axId val="172996991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00684943"/>
        <c:crosses val="autoZero"/>
        <c:auto val="1"/>
        <c:lblAlgn val="ctr"/>
        <c:lblOffset val="100"/>
        <c:noMultiLvlLbl val="0"/>
      </c:catAx>
      <c:valAx>
        <c:axId val="1900684943"/>
        <c:scaling>
          <c:orientation val="minMax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7299699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98BB9-1211-4044-891A-D2797552DE5C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89DC8C-7FF5-4B7D-AE07-F4BA622A90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5595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98BB9-1211-4044-891A-D2797552DE5C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89DC8C-7FF5-4B7D-AE07-F4BA622A90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54967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98BB9-1211-4044-891A-D2797552DE5C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89DC8C-7FF5-4B7D-AE07-F4BA622A90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455035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98BB9-1211-4044-891A-D2797552DE5C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89DC8C-7FF5-4B7D-AE07-F4BA622A90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95591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98BB9-1211-4044-891A-D2797552DE5C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89DC8C-7FF5-4B7D-AE07-F4BA622A90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18379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98BB9-1211-4044-891A-D2797552DE5C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89DC8C-7FF5-4B7D-AE07-F4BA622A90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84460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98BB9-1211-4044-891A-D2797552DE5C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89DC8C-7FF5-4B7D-AE07-F4BA622A90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17624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98BB9-1211-4044-891A-D2797552DE5C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89DC8C-7FF5-4B7D-AE07-F4BA622A90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79726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98BB9-1211-4044-891A-D2797552DE5C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89DC8C-7FF5-4B7D-AE07-F4BA622A90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70659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98BB9-1211-4044-891A-D2797552DE5C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89DC8C-7FF5-4B7D-AE07-F4BA622A90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60415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6898BB9-1211-4044-891A-D2797552DE5C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89DC8C-7FF5-4B7D-AE07-F4BA622A90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56531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898BB9-1211-4044-891A-D2797552DE5C}" type="datetimeFigureOut">
              <a:rPr lang="en-US" smtClean="0"/>
              <a:t>5/1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89DC8C-7FF5-4B7D-AE07-F4BA622A90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89251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9768797C-6C60-DA1A-5AC4-2441847882ED}"/>
              </a:ext>
            </a:extLst>
          </p:cNvPr>
          <p:cNvGrpSpPr/>
          <p:nvPr/>
        </p:nvGrpSpPr>
        <p:grpSpPr>
          <a:xfrm>
            <a:off x="349884" y="287033"/>
            <a:ext cx="6158233" cy="7093016"/>
            <a:chOff x="349884" y="287033"/>
            <a:chExt cx="6158233" cy="7093016"/>
          </a:xfrm>
        </p:grpSpPr>
        <p:graphicFrame>
          <p:nvGraphicFramePr>
            <p:cNvPr id="5" name="Chart 4">
              <a:extLst>
                <a:ext uri="{FF2B5EF4-FFF2-40B4-BE49-F238E27FC236}">
                  <a16:creationId xmlns:a16="http://schemas.microsoft.com/office/drawing/2014/main" id="{897E63D2-AEC0-6224-02C1-BCD127A5EAF7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66398263"/>
                </p:ext>
              </p:extLst>
            </p:nvPr>
          </p:nvGraphicFramePr>
          <p:xfrm>
            <a:off x="1274839" y="287033"/>
            <a:ext cx="3831092" cy="283599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64AD4745-7E50-4655-C262-6436117B3673}"/>
                </a:ext>
              </a:extLst>
            </p:cNvPr>
            <p:cNvSpPr txBox="1"/>
            <p:nvPr/>
          </p:nvSpPr>
          <p:spPr>
            <a:xfrm>
              <a:off x="1796062" y="1659997"/>
              <a:ext cx="74732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,089 (56%)</a:t>
              </a:r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7CDF4977-F195-359E-378C-AD24D8456390}"/>
                </a:ext>
              </a:extLst>
            </p:cNvPr>
            <p:cNvSpPr txBox="1"/>
            <p:nvPr/>
          </p:nvSpPr>
          <p:spPr>
            <a:xfrm>
              <a:off x="2121160" y="394935"/>
              <a:ext cx="6607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633 (17%)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3721232E-7FC6-4D62-98D8-EB832DC6ED5E}"/>
                </a:ext>
              </a:extLst>
            </p:cNvPr>
            <p:cNvSpPr txBox="1"/>
            <p:nvPr/>
          </p:nvSpPr>
          <p:spPr>
            <a:xfrm>
              <a:off x="3448356" y="356938"/>
              <a:ext cx="6607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454 (12%)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DCB29438-CE68-7CD4-4EA2-42573C87FA57}"/>
                </a:ext>
              </a:extLst>
            </p:cNvPr>
            <p:cNvSpPr txBox="1"/>
            <p:nvPr/>
          </p:nvSpPr>
          <p:spPr>
            <a:xfrm>
              <a:off x="3846466" y="655229"/>
              <a:ext cx="6030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76 (8%)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22BABCE9-3995-59E6-99AD-5DDB0E361622}"/>
                </a:ext>
              </a:extLst>
            </p:cNvPr>
            <p:cNvSpPr txBox="1"/>
            <p:nvPr/>
          </p:nvSpPr>
          <p:spPr>
            <a:xfrm>
              <a:off x="4040677" y="1253689"/>
              <a:ext cx="5453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82 (2%)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AB57DCCD-2291-2CEB-4230-7A7B335B563C}"/>
                </a:ext>
              </a:extLst>
            </p:cNvPr>
            <p:cNvSpPr txBox="1"/>
            <p:nvPr/>
          </p:nvSpPr>
          <p:spPr>
            <a:xfrm>
              <a:off x="3999687" y="1064372"/>
              <a:ext cx="60305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149 (4%)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9E5D05E2-4405-50FF-3A00-3B96EB75E26C}"/>
                </a:ext>
              </a:extLst>
            </p:cNvPr>
            <p:cNvSpPr txBox="1"/>
            <p:nvPr/>
          </p:nvSpPr>
          <p:spPr>
            <a:xfrm>
              <a:off x="3997132" y="933250"/>
              <a:ext cx="5453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26 (1%)</a:t>
              </a:r>
            </a:p>
          </p:txBody>
        </p:sp>
        <p:graphicFrame>
          <p:nvGraphicFramePr>
            <p:cNvPr id="14" name="图表 3">
              <a:extLst>
                <a:ext uri="{FF2B5EF4-FFF2-40B4-BE49-F238E27FC236}">
                  <a16:creationId xmlns:a16="http://schemas.microsoft.com/office/drawing/2014/main" id="{CC4E8E71-9480-2D31-5867-DAF4BC84DE5A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49520717"/>
                </p:ext>
              </p:extLst>
            </p:nvPr>
          </p:nvGraphicFramePr>
          <p:xfrm>
            <a:off x="565327" y="3411358"/>
            <a:ext cx="1580060" cy="2835999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BED25759-9486-E32A-AC17-63B5C162BEC0}"/>
                </a:ext>
              </a:extLst>
            </p:cNvPr>
            <p:cNvSpPr txBox="1"/>
            <p:nvPr/>
          </p:nvSpPr>
          <p:spPr>
            <a:xfrm rot="16200000">
              <a:off x="-399326" y="4345283"/>
              <a:ext cx="17138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Hormone responsive elements</a:t>
              </a:r>
            </a:p>
          </p:txBody>
        </p: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D4089D2A-7197-0B48-2FDF-17DC237B6EB9}"/>
                </a:ext>
              </a:extLst>
            </p:cNvPr>
            <p:cNvGrpSpPr/>
            <p:nvPr/>
          </p:nvGrpSpPr>
          <p:grpSpPr>
            <a:xfrm>
              <a:off x="2301030" y="3486184"/>
              <a:ext cx="1856940" cy="3317446"/>
              <a:chOff x="3665927" y="3293529"/>
              <a:chExt cx="1856940" cy="3317446"/>
            </a:xfrm>
          </p:grpSpPr>
          <p:graphicFrame>
            <p:nvGraphicFramePr>
              <p:cNvPr id="17" name="图表 8">
                <a:extLst>
                  <a:ext uri="{FF2B5EF4-FFF2-40B4-BE49-F238E27FC236}">
                    <a16:creationId xmlns:a16="http://schemas.microsoft.com/office/drawing/2014/main" id="{29944310-5BE9-84D4-2E9B-C74C314472D0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403958134"/>
                  </p:ext>
                </p:extLst>
              </p:nvPr>
            </p:nvGraphicFramePr>
            <p:xfrm>
              <a:off x="3665927" y="3293529"/>
              <a:ext cx="1856940" cy="331744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72D004F3-E16C-3B37-40BD-2ECBE91845A0}"/>
                  </a:ext>
                </a:extLst>
              </p:cNvPr>
              <p:cNvSpPr txBox="1"/>
              <p:nvPr/>
            </p:nvSpPr>
            <p:spPr>
              <a:xfrm rot="16200000">
                <a:off x="3048130" y="4205785"/>
                <a:ext cx="145103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Stress responsive elements</a:t>
                </a:r>
              </a:p>
            </p:txBody>
          </p:sp>
        </p:grp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1370C03A-C6FE-2771-DAB8-101680652938}"/>
                </a:ext>
              </a:extLst>
            </p:cNvPr>
            <p:cNvGrpSpPr/>
            <p:nvPr/>
          </p:nvGrpSpPr>
          <p:grpSpPr>
            <a:xfrm>
              <a:off x="4184464" y="3355062"/>
              <a:ext cx="2323653" cy="4024987"/>
              <a:chOff x="5744296" y="3145577"/>
              <a:chExt cx="2161677" cy="3712423"/>
            </a:xfrm>
          </p:grpSpPr>
          <p:graphicFrame>
            <p:nvGraphicFramePr>
              <p:cNvPr id="20" name="图表 7">
                <a:extLst>
                  <a:ext uri="{FF2B5EF4-FFF2-40B4-BE49-F238E27FC236}">
                    <a16:creationId xmlns:a16="http://schemas.microsoft.com/office/drawing/2014/main" id="{107828F2-7875-C46B-3043-9CEF0065ADD9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921350892"/>
                  </p:ext>
                </p:extLst>
              </p:nvPr>
            </p:nvGraphicFramePr>
            <p:xfrm>
              <a:off x="5744296" y="3145577"/>
              <a:ext cx="2161677" cy="371242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2FAEAE01-8EAC-DA9E-9C96-482F03E97EFF}"/>
                  </a:ext>
                </a:extLst>
              </p:cNvPr>
              <p:cNvSpPr txBox="1"/>
              <p:nvPr/>
            </p:nvSpPr>
            <p:spPr>
              <a:xfrm rot="16200000">
                <a:off x="5155756" y="4052174"/>
                <a:ext cx="149111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Growth responsive elements</a:t>
                </a:r>
              </a:p>
            </p:txBody>
          </p:sp>
        </p:grp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3CD6F907-95FE-A41B-656E-E9CB4FA3477C}"/>
                </a:ext>
              </a:extLst>
            </p:cNvPr>
            <p:cNvSpPr txBox="1"/>
            <p:nvPr/>
          </p:nvSpPr>
          <p:spPr>
            <a:xfrm>
              <a:off x="1066656" y="3502969"/>
              <a:ext cx="5774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 = 276 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1F968E00-BB4D-513E-3015-145D17F65D54}"/>
                </a:ext>
              </a:extLst>
            </p:cNvPr>
            <p:cNvSpPr txBox="1"/>
            <p:nvPr/>
          </p:nvSpPr>
          <p:spPr>
            <a:xfrm>
              <a:off x="3441825" y="3502969"/>
              <a:ext cx="5774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 = 149 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CA6D9AC2-937C-768B-8449-149DB68BDC64}"/>
                </a:ext>
              </a:extLst>
            </p:cNvPr>
            <p:cNvSpPr txBox="1"/>
            <p:nvPr/>
          </p:nvSpPr>
          <p:spPr>
            <a:xfrm>
              <a:off x="5043711" y="3502969"/>
              <a:ext cx="5196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N = 82 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F3787E4D-8ACA-7340-5C34-2EDEF6175CD8}"/>
                </a:ext>
              </a:extLst>
            </p:cNvPr>
            <p:cNvSpPr txBox="1"/>
            <p:nvPr/>
          </p:nvSpPr>
          <p:spPr>
            <a:xfrm>
              <a:off x="1612167" y="372680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08F63125-C0A5-5B22-EF1E-CA6C856A1531}"/>
                </a:ext>
              </a:extLst>
            </p:cNvPr>
            <p:cNvSpPr txBox="1"/>
            <p:nvPr/>
          </p:nvSpPr>
          <p:spPr>
            <a:xfrm>
              <a:off x="565327" y="3131425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508927D4-B706-6717-9C46-651F9A81E470}"/>
                </a:ext>
              </a:extLst>
            </p:cNvPr>
            <p:cNvSpPr txBox="1"/>
            <p:nvPr/>
          </p:nvSpPr>
          <p:spPr>
            <a:xfrm>
              <a:off x="4455230" y="3131425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5352CC2D-3A98-C4DB-2F17-5D1B4BD7CF33}"/>
                </a:ext>
              </a:extLst>
            </p:cNvPr>
            <p:cNvSpPr txBox="1"/>
            <p:nvPr/>
          </p:nvSpPr>
          <p:spPr>
            <a:xfrm>
              <a:off x="2530662" y="3131425"/>
              <a:ext cx="2776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</p:grpSp>
      <p:sp>
        <p:nvSpPr>
          <p:cNvPr id="35" name="TextBox 34">
            <a:extLst>
              <a:ext uri="{FF2B5EF4-FFF2-40B4-BE49-F238E27FC236}">
                <a16:creationId xmlns:a16="http://schemas.microsoft.com/office/drawing/2014/main" id="{AE53BE9F-D035-A8F4-177B-9A6912E7CDE5}"/>
              </a:ext>
            </a:extLst>
          </p:cNvPr>
          <p:cNvSpPr txBox="1"/>
          <p:nvPr/>
        </p:nvSpPr>
        <p:spPr>
          <a:xfrm>
            <a:off x="349883" y="7143036"/>
            <a:ext cx="604838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3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,500-bp upstream cis-regulatory elements of the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ZF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 and their potential biology.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is-regulatory elements of the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ZF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. A total of 3,709 cis-regulatory elements that are classified into 53 types were identified in the 1,500-bp upstream regions of the </a:t>
            </a:r>
            <a:r>
              <a:rPr lang="en-US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gZFP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enes.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The cis-regulatory elements responsive to hormones.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JA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methyl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jasmonate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The cis-regulatory elements responsive to environmental stresses. (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The cis-regulatory elements responsive to plant growth developments. </a:t>
            </a:r>
          </a:p>
        </p:txBody>
      </p:sp>
    </p:spTree>
    <p:extLst>
      <p:ext uri="{BB962C8B-B14F-4D97-AF65-F5344CB8AC3E}">
        <p14:creationId xmlns:p14="http://schemas.microsoft.com/office/powerpoint/2010/main" val="13293829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6</TotalTime>
  <Words>139</Words>
  <Application>Microsoft Office PowerPoint</Application>
  <PresentationFormat>On-screen Show (4:3)</PresentationFormat>
  <Paragraphs>1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Texas A and M AgriLif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ang, Meiping</dc:creator>
  <cp:lastModifiedBy>Zhang, Hongbin</cp:lastModifiedBy>
  <cp:revision>7</cp:revision>
  <dcterms:created xsi:type="dcterms:W3CDTF">2022-05-16T20:29:10Z</dcterms:created>
  <dcterms:modified xsi:type="dcterms:W3CDTF">2022-05-17T22:59:27Z</dcterms:modified>
</cp:coreProperties>
</file>